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09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417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497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517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929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253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751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409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921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509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813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360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98143" y="741872"/>
            <a:ext cx="7384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README </a:t>
            </a:r>
            <a:r>
              <a:rPr lang="en-US" dirty="0"/>
              <a:t>- Fig 1R Y635C E756Q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06436" y="1620163"/>
            <a:ext cx="8402126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dirty="0" smtClean="0"/>
              <a:t>Perform a blind analysis of gephyrin and spine density and size from </a:t>
            </a:r>
            <a:r>
              <a:rPr lang="en-US" dirty="0"/>
              <a:t>17 Y635C </a:t>
            </a:r>
            <a:r>
              <a:rPr lang="en-US" smtClean="0"/>
              <a:t>E756Q cells.</a:t>
            </a:r>
            <a:endParaRPr lang="en-US" dirty="0" smtClean="0"/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Randomly select a subset of cells whose gephyrin and spine measurements are closest to the group average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From the selected cells, identify one ROI (dendritic segment) that is free of overlapping dendrites above or below the targeted region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Crop the image at the center of the selected ROI to ensure clear visualization of gephyrin and spines. 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/>
              <a:t>Generate a dual-color two-photon image stack (512 × 512 pixels, 0.047 µm/pixel resolution, 1 µm z-steps</a:t>
            </a:r>
            <a:r>
              <a:rPr lang="en-US" dirty="0" smtClean="0"/>
              <a:t>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2370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05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U Denver | Anschutz Medical Camp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 Chan Oh</dc:creator>
  <cp:lastModifiedBy>Won Chan Oh</cp:lastModifiedBy>
  <cp:revision>4</cp:revision>
  <dcterms:created xsi:type="dcterms:W3CDTF">2025-08-11T17:05:23Z</dcterms:created>
  <dcterms:modified xsi:type="dcterms:W3CDTF">2025-08-11T17:35:46Z</dcterms:modified>
</cp:coreProperties>
</file>